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998"/>
    <p:restoredTop sz="95884"/>
  </p:normalViewPr>
  <p:slideViewPr>
    <p:cSldViewPr snapToGrid="0">
      <p:cViewPr varScale="1">
        <p:scale>
          <a:sx n="74" d="100"/>
          <a:sy n="74" d="100"/>
        </p:scale>
        <p:origin x="176" y="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D3D45A-B82C-364B-B118-B52AE781E2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05AA23-3A27-8C93-ED5A-DB4292814A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5124AC-79EE-6FBB-101F-C70EBB4F5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56D07C-0ABA-8900-5D6F-F51B14AFA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8075BD-E945-F4F7-17BB-F28FCE9D3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45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9A09E4-F68D-B56E-842D-5E3E25075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6844F0-B2AF-60C9-DAF6-5DCFC2311B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8C1B0-9558-73BF-4539-E7BC7297E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029DD-060C-1F5F-49E9-DDEAF867A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5F32A7-2DF5-784E-26F2-E368C2B4B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65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937128-1682-FC83-53B2-BFE6A0BAD9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23F3C5-87A2-8A6C-A0F0-B8FAB93E6C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9E9411-9BC3-A57F-C000-8B729CEF3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A0A95-1B84-8A62-067B-2D4CFB24A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404C0-E735-D875-D658-1079B008B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940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892E9-C118-0625-4D1B-BC596A81B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E5F9D2-7DB5-703A-9FF7-F95E91ADD8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167BA2-2CEA-8E2E-D840-514232148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F49DAB-A7FA-7485-CDD7-5F61F3289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54B6F-BECC-0508-54AA-DE2F68F3D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102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2E349-68FD-1409-F9A1-14B267A34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AAB6DE-AB8F-9B46-D6F0-1A73A9DC51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313521-CADE-E4D4-161B-BC3F34BB3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A3E55-F385-9BB9-7455-A484DB065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8361B1-55A4-7787-F8FC-675FFA8DD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674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4566D-35E1-9539-0EAD-FC05309F0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DC7661-6617-AF31-48F6-1D7536C285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96CF91-73EB-1430-8E28-79D63E0E98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775506-B205-1460-10A0-1BE15F781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3E389F-1620-BD1B-06C2-78987DD99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1780BF-2A09-D4EC-6177-1FF54E18A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230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6F485-18DC-BCEA-7323-584EC1A3F3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D7D4B1-B8C3-AFC2-79BD-5FF35E469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723DB7-983F-33B2-D701-7916FDF7F4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33D9CC-A41B-4EC4-97DB-5C6A66E36A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811D08-EA1F-7767-A6C6-36C37F0772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C32A3C-ED87-C585-E652-4D8815D0A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53EF0-C581-233C-AA23-8018E356E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E362FC-2B42-85AA-A136-EACFBC795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05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680BD5-7AD3-A5B2-EC7F-9800E20FD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A825E0-B9F1-268E-C90C-E6FE69551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DD0611-319B-F3F5-150C-890550BB4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55BFA1-C175-7E02-A192-11B92588E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022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FB0E66-4E85-9D18-1810-5232D4DBC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95F81A-5FBC-FABA-6D0B-989AFDC4B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801E31-9DE1-5F71-9EE3-B0B65E27F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67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18434-837C-7051-022F-E6FBC3C614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51F8D-E39C-4CF7-3CE5-7F7525F1D9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2A9532-8453-54B2-B324-B429017E2A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0433A7-B00A-86C8-9174-8FFAEB81F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5DDE46-35EA-51C2-2B2B-3460611A6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0F2C11-91BF-7D41-3859-DDBB8F68C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04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E63DE-96E9-F868-D336-1805114F4C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02B4B4-D4A3-3FFF-0A88-FE70287FF9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A3B6DE-5B0F-8E4A-AA10-396BFA4FAB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2AD485-092C-43F7-088A-1D35F8212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873F36-093C-EC62-87BF-4E00EC65B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C55089-1F66-A2C5-2D48-36A7E8C2B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19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8FE2AA-0ACE-A30D-0B12-E8EF2B52C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DA53B0-D67C-491E-90D1-E9373B0711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E8C282-345D-07CE-39DB-372DE93A84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4B4EC-8635-1A43-8559-E43601F83471}" type="datetimeFigureOut">
              <a:rPr lang="en-US" smtClean="0"/>
              <a:t>1/1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6530A8-E97C-9D78-E2BE-6232CE3F7E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1F66D-28D3-56B2-222B-154B56819E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A27FB-8937-554B-8FBF-DD19B2AB70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508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8E4C16-9D25-F182-78AF-ADCE85A8F61F}"/>
              </a:ext>
            </a:extLst>
          </p:cNvPr>
          <p:cNvSpPr txBox="1"/>
          <p:nvPr/>
        </p:nvSpPr>
        <p:spPr>
          <a:xfrm>
            <a:off x="0" y="-83130"/>
            <a:ext cx="119491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4524599-381C-9415-02A4-EE39D23423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822"/>
          <a:stretch/>
        </p:blipFill>
        <p:spPr>
          <a:xfrm>
            <a:off x="6981715" y="593785"/>
            <a:ext cx="2589402" cy="31904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F77FE7A-8765-637B-E016-A09A1DF6994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495"/>
          <a:stretch/>
        </p:blipFill>
        <p:spPr>
          <a:xfrm>
            <a:off x="4120993" y="528791"/>
            <a:ext cx="2589401" cy="321027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CA5849F-0DAC-F001-BF61-439899802CB4}"/>
              </a:ext>
            </a:extLst>
          </p:cNvPr>
          <p:cNvSpPr txBox="1"/>
          <p:nvPr/>
        </p:nvSpPr>
        <p:spPr>
          <a:xfrm>
            <a:off x="4022712" y="285542"/>
            <a:ext cx="3258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 Surgical Tissue-ChIP-seq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D43D2E-83E5-1F5C-BE9A-3F5C6568722A}"/>
              </a:ext>
            </a:extLst>
          </p:cNvPr>
          <p:cNvSpPr txBox="1"/>
          <p:nvPr/>
        </p:nvSpPr>
        <p:spPr>
          <a:xfrm>
            <a:off x="6142247" y="2221303"/>
            <a:ext cx="1364476" cy="369332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26D3638-622F-2B21-6FF3-195E4C455CD9}"/>
              </a:ext>
            </a:extLst>
          </p:cNvPr>
          <p:cNvSpPr/>
          <p:nvPr/>
        </p:nvSpPr>
        <p:spPr>
          <a:xfrm>
            <a:off x="5617285" y="3326014"/>
            <a:ext cx="428733" cy="1395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4923248-00FF-0D42-6A56-ED0CDDC2B08B}"/>
              </a:ext>
            </a:extLst>
          </p:cNvPr>
          <p:cNvSpPr/>
          <p:nvPr/>
        </p:nvSpPr>
        <p:spPr>
          <a:xfrm>
            <a:off x="4323549" y="3323847"/>
            <a:ext cx="463402" cy="143851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CB0B6CE-93CB-E153-2961-1E7702EDF903}"/>
              </a:ext>
            </a:extLst>
          </p:cNvPr>
          <p:cNvSpPr/>
          <p:nvPr/>
        </p:nvSpPr>
        <p:spPr>
          <a:xfrm>
            <a:off x="5200424" y="3323847"/>
            <a:ext cx="428733" cy="143851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EDF6817-BBD6-1594-CB7C-E19F801897D6}"/>
              </a:ext>
            </a:extLst>
          </p:cNvPr>
          <p:cNvSpPr/>
          <p:nvPr/>
        </p:nvSpPr>
        <p:spPr>
          <a:xfrm>
            <a:off x="4767982" y="3323847"/>
            <a:ext cx="428733" cy="143851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446A636-BE80-1FA3-59AA-E89F60336DC0}"/>
              </a:ext>
            </a:extLst>
          </p:cNvPr>
          <p:cNvSpPr/>
          <p:nvPr/>
        </p:nvSpPr>
        <p:spPr>
          <a:xfrm>
            <a:off x="4115733" y="3323847"/>
            <a:ext cx="242188" cy="143851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FCEBA4F-3562-5FF9-5143-4471B0447B18}"/>
              </a:ext>
            </a:extLst>
          </p:cNvPr>
          <p:cNvSpPr/>
          <p:nvPr/>
        </p:nvSpPr>
        <p:spPr>
          <a:xfrm>
            <a:off x="6268017" y="3326014"/>
            <a:ext cx="428733" cy="1395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529499F-BAF3-402E-C9DF-24609CC26492}"/>
              </a:ext>
            </a:extLst>
          </p:cNvPr>
          <p:cNvSpPr/>
          <p:nvPr/>
        </p:nvSpPr>
        <p:spPr>
          <a:xfrm>
            <a:off x="6041889" y="3323847"/>
            <a:ext cx="242188" cy="143851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936DB5E-D21F-F272-2342-32250B96C1A6}"/>
              </a:ext>
            </a:extLst>
          </p:cNvPr>
          <p:cNvSpPr/>
          <p:nvPr/>
        </p:nvSpPr>
        <p:spPr>
          <a:xfrm>
            <a:off x="6986200" y="3347792"/>
            <a:ext cx="428733" cy="1395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7449B02-6131-4F13-2F97-9E6D472BE5E4}"/>
              </a:ext>
            </a:extLst>
          </p:cNvPr>
          <p:cNvSpPr/>
          <p:nvPr/>
        </p:nvSpPr>
        <p:spPr>
          <a:xfrm>
            <a:off x="7412184" y="3345625"/>
            <a:ext cx="428733" cy="143851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F28B2B7-7A6B-027F-2695-BDDE14440CAE}"/>
              </a:ext>
            </a:extLst>
          </p:cNvPr>
          <p:cNvSpPr/>
          <p:nvPr/>
        </p:nvSpPr>
        <p:spPr>
          <a:xfrm>
            <a:off x="7844951" y="3347792"/>
            <a:ext cx="211419" cy="139516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9C4C4E6-3947-06DE-4A42-B5A7DDFEC4B1}"/>
              </a:ext>
            </a:extLst>
          </p:cNvPr>
          <p:cNvSpPr/>
          <p:nvPr/>
        </p:nvSpPr>
        <p:spPr>
          <a:xfrm>
            <a:off x="9127007" y="3347793"/>
            <a:ext cx="417945" cy="139514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FFDADA5-10D2-78D6-42FD-C4A74CE084FB}"/>
              </a:ext>
            </a:extLst>
          </p:cNvPr>
          <p:cNvSpPr/>
          <p:nvPr/>
        </p:nvSpPr>
        <p:spPr>
          <a:xfrm>
            <a:off x="8056837" y="3345625"/>
            <a:ext cx="428733" cy="143851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65DA772-3861-5F5A-51C4-EEC5306B2A16}"/>
              </a:ext>
            </a:extLst>
          </p:cNvPr>
          <p:cNvSpPr/>
          <p:nvPr/>
        </p:nvSpPr>
        <p:spPr>
          <a:xfrm>
            <a:off x="8698274" y="3347792"/>
            <a:ext cx="428733" cy="139516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6E32B47-7A73-F400-EB53-D4F0EBC781CD}"/>
              </a:ext>
            </a:extLst>
          </p:cNvPr>
          <p:cNvSpPr/>
          <p:nvPr/>
        </p:nvSpPr>
        <p:spPr>
          <a:xfrm>
            <a:off x="8482354" y="3347792"/>
            <a:ext cx="211419" cy="139516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065083B-F742-8146-846A-FC1686A0CA4B}"/>
              </a:ext>
            </a:extLst>
          </p:cNvPr>
          <p:cNvSpPr/>
          <p:nvPr/>
        </p:nvSpPr>
        <p:spPr>
          <a:xfrm>
            <a:off x="8482998" y="47945"/>
            <a:ext cx="145078" cy="15863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B89349E-19A3-4CF7-9B64-3F145176E712}"/>
              </a:ext>
            </a:extLst>
          </p:cNvPr>
          <p:cNvSpPr/>
          <p:nvPr/>
        </p:nvSpPr>
        <p:spPr>
          <a:xfrm>
            <a:off x="8482998" y="254986"/>
            <a:ext cx="145078" cy="15334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12208F1-E207-7C66-BB3F-A287E96B9752}"/>
              </a:ext>
            </a:extLst>
          </p:cNvPr>
          <p:cNvSpPr/>
          <p:nvPr/>
        </p:nvSpPr>
        <p:spPr>
          <a:xfrm>
            <a:off x="8482999" y="468540"/>
            <a:ext cx="145077" cy="1533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1F5B80C-8895-EC80-1195-7BACE101EB1A}"/>
              </a:ext>
            </a:extLst>
          </p:cNvPr>
          <p:cNvSpPr txBox="1"/>
          <p:nvPr/>
        </p:nvSpPr>
        <p:spPr>
          <a:xfrm>
            <a:off x="8628076" y="-38174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pileps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4FDCBB5-4634-C5C6-F68C-5C4D5DCFB60F}"/>
              </a:ext>
            </a:extLst>
          </p:cNvPr>
          <p:cNvSpPr txBox="1"/>
          <p:nvPr/>
        </p:nvSpPr>
        <p:spPr>
          <a:xfrm>
            <a:off x="8628076" y="197120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DH1 W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AAA8F4F-30E4-17A6-2465-B9794AC94AB3}"/>
              </a:ext>
            </a:extLst>
          </p:cNvPr>
          <p:cNvSpPr txBox="1"/>
          <p:nvPr/>
        </p:nvSpPr>
        <p:spPr>
          <a:xfrm>
            <a:off x="8628076" y="391999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DH1 mut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1A2A0CE-06FC-2943-E38A-BE429AEB79C2}"/>
              </a:ext>
            </a:extLst>
          </p:cNvPr>
          <p:cNvSpPr/>
          <p:nvPr/>
        </p:nvSpPr>
        <p:spPr>
          <a:xfrm>
            <a:off x="4083186" y="3440815"/>
            <a:ext cx="5674385" cy="3573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A107F607-C722-34CE-4D6B-64B973B181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164" y="4020069"/>
            <a:ext cx="2397383" cy="284328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C031019-9E26-4DD9-25FE-BEAC84569DDB}"/>
              </a:ext>
            </a:extLst>
          </p:cNvPr>
          <p:cNvSpPr txBox="1"/>
          <p:nvPr/>
        </p:nvSpPr>
        <p:spPr>
          <a:xfrm>
            <a:off x="4456726" y="4982848"/>
            <a:ext cx="1364476" cy="369332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651C71C0-9C39-93EA-041D-0ED57B49C8B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9167"/>
          <a:stretch/>
        </p:blipFill>
        <p:spPr>
          <a:xfrm>
            <a:off x="5266168" y="4020069"/>
            <a:ext cx="2168593" cy="2608502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FF1072B7-7EA5-2AFB-B9EE-E58134FE164C}"/>
              </a:ext>
            </a:extLst>
          </p:cNvPr>
          <p:cNvSpPr/>
          <p:nvPr/>
        </p:nvSpPr>
        <p:spPr>
          <a:xfrm>
            <a:off x="5186015" y="6166900"/>
            <a:ext cx="1681202" cy="4410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02E55E1-E47F-29D5-B2AD-5A00BDEBFB91}"/>
              </a:ext>
            </a:extLst>
          </p:cNvPr>
          <p:cNvSpPr/>
          <p:nvPr/>
        </p:nvSpPr>
        <p:spPr>
          <a:xfrm>
            <a:off x="5483583" y="6177294"/>
            <a:ext cx="1831226" cy="4410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9D84BFB7-BC10-448F-9B3A-D7D0816BA0C4}"/>
              </a:ext>
            </a:extLst>
          </p:cNvPr>
          <p:cNvSpPr/>
          <p:nvPr/>
        </p:nvSpPr>
        <p:spPr>
          <a:xfrm>
            <a:off x="6357217" y="6177294"/>
            <a:ext cx="1058575" cy="172706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B9E33C0-A2AD-2EBD-55DC-0022589AC945}"/>
              </a:ext>
            </a:extLst>
          </p:cNvPr>
          <p:cNvSpPr/>
          <p:nvPr/>
        </p:nvSpPr>
        <p:spPr>
          <a:xfrm>
            <a:off x="5288806" y="6156506"/>
            <a:ext cx="1068412" cy="193494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9E1A19A3-FF61-3AB7-5450-2E60821A8CD6}"/>
              </a:ext>
            </a:extLst>
          </p:cNvPr>
          <p:cNvSpPr/>
          <p:nvPr/>
        </p:nvSpPr>
        <p:spPr>
          <a:xfrm>
            <a:off x="3702258" y="3612363"/>
            <a:ext cx="2589401" cy="3781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98BC96B-A6A4-2108-DC8F-4F208EF1B96B}"/>
              </a:ext>
            </a:extLst>
          </p:cNvPr>
          <p:cNvSpPr txBox="1"/>
          <p:nvPr/>
        </p:nvSpPr>
        <p:spPr>
          <a:xfrm>
            <a:off x="196896" y="359517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 LBH-treated HK252 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4D11D08F-76C6-E3CF-D021-4EAEAD9A85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77806" y="4084918"/>
            <a:ext cx="2255182" cy="2620182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B308E0A7-667D-6848-8EBC-6ACE4E0A519C}"/>
              </a:ext>
            </a:extLst>
          </p:cNvPr>
          <p:cNvSpPr txBox="1"/>
          <p:nvPr/>
        </p:nvSpPr>
        <p:spPr>
          <a:xfrm>
            <a:off x="7722641" y="568728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5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2AB1334-B26D-D4DC-094D-F8FDD04B3AF5}"/>
              </a:ext>
            </a:extLst>
          </p:cNvPr>
          <p:cNvSpPr txBox="1"/>
          <p:nvPr/>
        </p:nvSpPr>
        <p:spPr>
          <a:xfrm>
            <a:off x="8628839" y="539500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9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89743EC3-888A-21C5-E9DE-96FEB389AD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80592" y="3981194"/>
            <a:ext cx="2255182" cy="271432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AF2D6BAD-E8AB-2CDC-55BD-34384B6FD33D}"/>
              </a:ext>
            </a:extLst>
          </p:cNvPr>
          <p:cNvSpPr txBox="1"/>
          <p:nvPr/>
        </p:nvSpPr>
        <p:spPr>
          <a:xfrm>
            <a:off x="3094507" y="55026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2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2D75822-2748-1AC9-A8B4-D61918771827}"/>
              </a:ext>
            </a:extLst>
          </p:cNvPr>
          <p:cNvSpPr txBox="1"/>
          <p:nvPr/>
        </p:nvSpPr>
        <p:spPr>
          <a:xfrm>
            <a:off x="4099680" y="55026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1F01044-91F2-C45B-8EFA-D01244B4F4FD}"/>
              </a:ext>
            </a:extLst>
          </p:cNvPr>
          <p:cNvSpPr txBox="1"/>
          <p:nvPr/>
        </p:nvSpPr>
        <p:spPr>
          <a:xfrm>
            <a:off x="0" y="367712"/>
            <a:ext cx="31727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UcPeriod"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2-HG Validation of IDH1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utant Glioma Model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B4D1E36-6DE6-D010-2CC1-0F5CF20668B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452404" y="3684882"/>
            <a:ext cx="1581792" cy="317441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9A53263-AB6B-9466-4868-CE19874F4E80}"/>
              </a:ext>
            </a:extLst>
          </p:cNvPr>
          <p:cNvSpPr txBox="1"/>
          <p:nvPr/>
        </p:nvSpPr>
        <p:spPr>
          <a:xfrm>
            <a:off x="5169871" y="364956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 LBH-treated HK252 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32246CC-0903-EADA-E5BA-DAA9FBB52BE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-29383" y="1006154"/>
            <a:ext cx="3802290" cy="2648207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0FFE1FD8-3F3D-2C78-A1D8-2D6761A3A025}"/>
              </a:ext>
            </a:extLst>
          </p:cNvPr>
          <p:cNvSpPr txBox="1"/>
          <p:nvPr/>
        </p:nvSpPr>
        <p:spPr>
          <a:xfrm>
            <a:off x="3258839" y="2300551"/>
            <a:ext cx="1159292" cy="369332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F20279F-EEDF-4BA9-D6D4-1F6FEF31138C}"/>
              </a:ext>
            </a:extLst>
          </p:cNvPr>
          <p:cNvSpPr/>
          <p:nvPr/>
        </p:nvSpPr>
        <p:spPr>
          <a:xfrm>
            <a:off x="1071640" y="1076372"/>
            <a:ext cx="1697685" cy="1993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0ACB7917-D3B9-32D4-407D-4EFB8F43D74C}"/>
              </a:ext>
            </a:extLst>
          </p:cNvPr>
          <p:cNvSpPr/>
          <p:nvPr/>
        </p:nvSpPr>
        <p:spPr>
          <a:xfrm>
            <a:off x="478657" y="6353370"/>
            <a:ext cx="2300951" cy="5046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0C587D7-FA6A-8CE4-7108-64C3948B454E}"/>
              </a:ext>
            </a:extLst>
          </p:cNvPr>
          <p:cNvSpPr/>
          <p:nvPr/>
        </p:nvSpPr>
        <p:spPr>
          <a:xfrm>
            <a:off x="1642476" y="6363094"/>
            <a:ext cx="1137132" cy="182547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E614ECD3-E97D-C21D-3273-28E146DC4352}"/>
              </a:ext>
            </a:extLst>
          </p:cNvPr>
          <p:cNvSpPr/>
          <p:nvPr/>
        </p:nvSpPr>
        <p:spPr>
          <a:xfrm>
            <a:off x="451459" y="6345803"/>
            <a:ext cx="1179722" cy="207727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5EF76EA0-DDEB-A16A-AEB9-7CB2A3A80A98}"/>
              </a:ext>
            </a:extLst>
          </p:cNvPr>
          <p:cNvSpPr/>
          <p:nvPr/>
        </p:nvSpPr>
        <p:spPr>
          <a:xfrm>
            <a:off x="10281623" y="3654361"/>
            <a:ext cx="948700" cy="3705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5BC5F4-F3EE-7AB8-FB41-9A421DFF133E}"/>
              </a:ext>
            </a:extLst>
          </p:cNvPr>
          <p:cNvSpPr txBox="1"/>
          <p:nvPr/>
        </p:nvSpPr>
        <p:spPr>
          <a:xfrm>
            <a:off x="10309227" y="3732698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342A08B-3C77-FB14-6932-341EE9F96B78}"/>
              </a:ext>
            </a:extLst>
          </p:cNvPr>
          <p:cNvSpPr txBox="1"/>
          <p:nvPr/>
        </p:nvSpPr>
        <p:spPr>
          <a:xfrm>
            <a:off x="-311172" y="4982848"/>
            <a:ext cx="1159292" cy="369332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553EAE9-0AFC-B46C-8303-F53AC6563441}"/>
              </a:ext>
            </a:extLst>
          </p:cNvPr>
          <p:cNvSpPr/>
          <p:nvPr/>
        </p:nvSpPr>
        <p:spPr>
          <a:xfrm>
            <a:off x="10196390" y="5579675"/>
            <a:ext cx="719511" cy="11254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330C3FD-BC80-AF8E-0337-2355507A658B}"/>
              </a:ext>
            </a:extLst>
          </p:cNvPr>
          <p:cNvSpPr/>
          <p:nvPr/>
        </p:nvSpPr>
        <p:spPr>
          <a:xfrm>
            <a:off x="11072522" y="3727660"/>
            <a:ext cx="895779" cy="6935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5BD19BA-104C-88F1-8082-AE9E20348930}"/>
              </a:ext>
            </a:extLst>
          </p:cNvPr>
          <p:cNvSpPr txBox="1"/>
          <p:nvPr/>
        </p:nvSpPr>
        <p:spPr>
          <a:xfrm>
            <a:off x="10249983" y="556560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4AD9AFE-375C-3380-A2A4-0B0F4B5A728D}"/>
              </a:ext>
            </a:extLst>
          </p:cNvPr>
          <p:cNvSpPr txBox="1"/>
          <p:nvPr/>
        </p:nvSpPr>
        <p:spPr>
          <a:xfrm>
            <a:off x="9854796" y="6391627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FBA5A90-B485-E29E-CEE0-96E1EA4BD141}"/>
              </a:ext>
            </a:extLst>
          </p:cNvPr>
          <p:cNvSpPr txBox="1"/>
          <p:nvPr/>
        </p:nvSpPr>
        <p:spPr>
          <a:xfrm>
            <a:off x="10823939" y="4053885"/>
            <a:ext cx="646331" cy="276999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4A48AC1-C7D7-B4F0-C326-3E781C811B4C}"/>
              </a:ext>
            </a:extLst>
          </p:cNvPr>
          <p:cNvSpPr txBox="1"/>
          <p:nvPr/>
        </p:nvSpPr>
        <p:spPr>
          <a:xfrm>
            <a:off x="10901737" y="3907581"/>
            <a:ext cx="909223" cy="276999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nM LBH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1AF3079-6B8B-F479-745C-FA2C84148B4B}"/>
              </a:ext>
            </a:extLst>
          </p:cNvPr>
          <p:cNvSpPr txBox="1"/>
          <p:nvPr/>
        </p:nvSpPr>
        <p:spPr>
          <a:xfrm>
            <a:off x="11155336" y="3907581"/>
            <a:ext cx="909223" cy="276999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nM LBH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6C4751A-6E6F-7B5B-C1F7-D88626D19B8B}"/>
              </a:ext>
            </a:extLst>
          </p:cNvPr>
          <p:cNvSpPr txBox="1"/>
          <p:nvPr/>
        </p:nvSpPr>
        <p:spPr>
          <a:xfrm>
            <a:off x="11380888" y="3907581"/>
            <a:ext cx="909223" cy="276999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nM LBH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35C8934-80E7-9D3B-D05B-EE888AAD2003}"/>
              </a:ext>
            </a:extLst>
          </p:cNvPr>
          <p:cNvSpPr/>
          <p:nvPr/>
        </p:nvSpPr>
        <p:spPr>
          <a:xfrm>
            <a:off x="2451359" y="1222147"/>
            <a:ext cx="145078" cy="15334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25CAEE49-062B-4A46-15B7-F7479764050B}"/>
              </a:ext>
            </a:extLst>
          </p:cNvPr>
          <p:cNvSpPr/>
          <p:nvPr/>
        </p:nvSpPr>
        <p:spPr>
          <a:xfrm>
            <a:off x="2451360" y="1564314"/>
            <a:ext cx="145077" cy="15334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D3D5851-074F-10E5-9287-6C750634AA58}"/>
              </a:ext>
            </a:extLst>
          </p:cNvPr>
          <p:cNvSpPr txBox="1"/>
          <p:nvPr/>
        </p:nvSpPr>
        <p:spPr>
          <a:xfrm>
            <a:off x="2596437" y="1164281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DH1 WT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95620F2-AEE6-D0BC-B6A0-AF4C9F38B072}"/>
              </a:ext>
            </a:extLst>
          </p:cNvPr>
          <p:cNvSpPr txBox="1"/>
          <p:nvPr/>
        </p:nvSpPr>
        <p:spPr>
          <a:xfrm>
            <a:off x="2596437" y="1487773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DH1 mu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40861C6-3E90-E123-075A-DF23FEEC4BE3}"/>
              </a:ext>
            </a:extLst>
          </p:cNvPr>
          <p:cNvSpPr txBox="1"/>
          <p:nvPr/>
        </p:nvSpPr>
        <p:spPr>
          <a:xfrm>
            <a:off x="9567923" y="-8158"/>
            <a:ext cx="2624077" cy="37548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 Cell line models underwent LC-MS analysis to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sure 2-HG production B. A panel of 12 surgically resected tissues (4 IDH1 WT glioma, 4 IDH1 mutant glioma and 4 control epilepsy tissue) underwent ChIP-seq with H3K27ac and H3K27me3 antibodies. C.,D. HK252 was treated with 15nM before undergoing ChIP-seq. Differentially regulated peaks are shown. E. Western blot analysis for total H3K27ac protein following increasing doses of LBH (HK252)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5833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4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rett, Matthew (garretm4)</dc:creator>
  <cp:lastModifiedBy>Garrett, Matthew (garretm4)</cp:lastModifiedBy>
  <cp:revision>1</cp:revision>
  <dcterms:created xsi:type="dcterms:W3CDTF">2023-01-19T01:44:24Z</dcterms:created>
  <dcterms:modified xsi:type="dcterms:W3CDTF">2023-01-19T01:45:08Z</dcterms:modified>
</cp:coreProperties>
</file>